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4" d="100"/>
          <a:sy n="84" d="100"/>
        </p:scale>
        <p:origin x="898" y="8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41DD1-F4D4-084F-BC46-6BCACFA29419}" type="datetimeFigureOut">
              <a:rPr lang="en-US" smtClean="0"/>
              <a:pPr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7CB32-3BA0-714F-8380-DBCD89B5D6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271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41DD1-F4D4-084F-BC46-6BCACFA29419}" type="datetimeFigureOut">
              <a:rPr lang="en-US" smtClean="0"/>
              <a:pPr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7CB32-3BA0-714F-8380-DBCD89B5D6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076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41DD1-F4D4-084F-BC46-6BCACFA29419}" type="datetimeFigureOut">
              <a:rPr lang="en-US" smtClean="0"/>
              <a:pPr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7CB32-3BA0-714F-8380-DBCD89B5D6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133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41DD1-F4D4-084F-BC46-6BCACFA29419}" type="datetimeFigureOut">
              <a:rPr lang="en-US" smtClean="0"/>
              <a:pPr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7CB32-3BA0-714F-8380-DBCD89B5D6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951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41DD1-F4D4-084F-BC46-6BCACFA29419}" type="datetimeFigureOut">
              <a:rPr lang="en-US" smtClean="0"/>
              <a:pPr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7CB32-3BA0-714F-8380-DBCD89B5D6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842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41DD1-F4D4-084F-BC46-6BCACFA29419}" type="datetimeFigureOut">
              <a:rPr lang="en-US" smtClean="0"/>
              <a:pPr/>
              <a:t>12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7CB32-3BA0-714F-8380-DBCD89B5D6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6933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41DD1-F4D4-084F-BC46-6BCACFA29419}" type="datetimeFigureOut">
              <a:rPr lang="en-US" smtClean="0"/>
              <a:pPr/>
              <a:t>12/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7CB32-3BA0-714F-8380-DBCD89B5D6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721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41DD1-F4D4-084F-BC46-6BCACFA29419}" type="datetimeFigureOut">
              <a:rPr lang="en-US" smtClean="0"/>
              <a:pPr/>
              <a:t>12/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7CB32-3BA0-714F-8380-DBCD89B5D6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432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41DD1-F4D4-084F-BC46-6BCACFA29419}" type="datetimeFigureOut">
              <a:rPr lang="en-US" smtClean="0"/>
              <a:pPr/>
              <a:t>12/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7CB32-3BA0-714F-8380-DBCD89B5D6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215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41DD1-F4D4-084F-BC46-6BCACFA29419}" type="datetimeFigureOut">
              <a:rPr lang="en-US" smtClean="0"/>
              <a:pPr/>
              <a:t>12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7CB32-3BA0-714F-8380-DBCD89B5D6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9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41DD1-F4D4-084F-BC46-6BCACFA29419}" type="datetimeFigureOut">
              <a:rPr lang="en-US" smtClean="0"/>
              <a:pPr/>
              <a:t>12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7CB32-3BA0-714F-8380-DBCD89B5D6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0743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41DD1-F4D4-084F-BC46-6BCACFA29419}" type="datetimeFigureOut">
              <a:rPr lang="en-US" smtClean="0"/>
              <a:pPr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67CB32-3BA0-714F-8380-DBCD89B5D6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778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6771" y="3743688"/>
            <a:ext cx="6272446" cy="2804008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7653" y="271049"/>
            <a:ext cx="5963190" cy="280799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07933" y="18195"/>
            <a:ext cx="29898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/>
                <a:cs typeface="Arial"/>
              </a:rPr>
              <a:t>A  Similarity of motif signatures</a:t>
            </a:r>
            <a:endParaRPr lang="en-US" sz="1600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62147" y="3456904"/>
            <a:ext cx="31381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/>
                <a:cs typeface="Arial"/>
              </a:rPr>
              <a:t>B</a:t>
            </a:r>
            <a:r>
              <a:rPr lang="en-US" sz="1600" dirty="0">
                <a:latin typeface="Arial"/>
                <a:cs typeface="Arial"/>
              </a:rPr>
              <a:t> </a:t>
            </a:r>
            <a:r>
              <a:rPr lang="en-US" sz="1600" dirty="0" smtClean="0">
                <a:latin typeface="Arial"/>
                <a:cs typeface="Arial"/>
              </a:rPr>
              <a:t> Similarity of TrEn sequences</a:t>
            </a:r>
            <a:endParaRPr lang="en-US" sz="1600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557642" y="3077639"/>
            <a:ext cx="40757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Randomly selected tissues from different developmental stages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557642" y="6535011"/>
            <a:ext cx="40757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Randomly selected tissues from different developmental stages</a:t>
            </a:r>
            <a:endParaRPr lang="en-US" sz="10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417377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24</Words>
  <Application>Microsoft Office PowerPoint</Application>
  <PresentationFormat>全屏显示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演示文稿</vt:lpstr>
    </vt:vector>
  </TitlesOfParts>
  <Company>IC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mitrios Kleftogiannis</dc:creator>
  <cp:lastModifiedBy>叶 绯钰</cp:lastModifiedBy>
  <cp:revision>21</cp:revision>
  <dcterms:created xsi:type="dcterms:W3CDTF">2018-02-26T16:19:52Z</dcterms:created>
  <dcterms:modified xsi:type="dcterms:W3CDTF">2018-12-09T15:28:29Z</dcterms:modified>
</cp:coreProperties>
</file>